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197"/>
  </p:normalViewPr>
  <p:slideViewPr>
    <p:cSldViewPr snapToGrid="0">
      <p:cViewPr varScale="1">
        <p:scale>
          <a:sx n="64" d="100"/>
          <a:sy n="64" d="100"/>
        </p:scale>
        <p:origin x="34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996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842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902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250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321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89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513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788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592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283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344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39A922-1596-F746-ADFB-0592D2E27BAD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CA7C5-2102-7B4E-9607-2B0958824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706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3AC4BFEF-71A4-9C12-8905-174327B2E078}"/>
              </a:ext>
            </a:extLst>
          </p:cNvPr>
          <p:cNvGrpSpPr/>
          <p:nvPr/>
        </p:nvGrpSpPr>
        <p:grpSpPr>
          <a:xfrm>
            <a:off x="1419845" y="348072"/>
            <a:ext cx="3889591" cy="10855467"/>
            <a:chOff x="1572245" y="124138"/>
            <a:chExt cx="3889591" cy="10855467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88949723-752F-2C20-DC69-CCFE22D9EF38}"/>
                </a:ext>
              </a:extLst>
            </p:cNvPr>
            <p:cNvGrpSpPr/>
            <p:nvPr/>
          </p:nvGrpSpPr>
          <p:grpSpPr>
            <a:xfrm>
              <a:off x="1572245" y="124138"/>
              <a:ext cx="3450203" cy="2797338"/>
              <a:chOff x="8491716" y="227445"/>
              <a:chExt cx="3495349" cy="2800686"/>
            </a:xfrm>
          </p:grpSpPr>
          <p:graphicFrame>
            <p:nvGraphicFramePr>
              <p:cNvPr id="39" name="Objeto 5">
                <a:extLst>
                  <a:ext uri="{FF2B5EF4-FFF2-40B4-BE49-F238E27FC236}">
                    <a16:creationId xmlns:a16="http://schemas.microsoft.com/office/drawing/2014/main" id="{9E43D746-675A-9B0A-A8A4-801A623E002C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28210821"/>
                  </p:ext>
                </p:extLst>
              </p:nvPr>
            </p:nvGraphicFramePr>
            <p:xfrm>
              <a:off x="8491716" y="227445"/>
              <a:ext cx="3495349" cy="28006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2" imgW="3797300" imgH="3035300" progId="">
                      <p:embed/>
                    </p:oleObj>
                  </mc:Choice>
                  <mc:Fallback>
                    <p:oleObj r:id="rId2" imgW="3797300" imgH="3035300" progId="">
                      <p:embed/>
                      <p:pic>
                        <p:nvPicPr>
                          <p:cNvPr id="33" name="Objeto 5">
                            <a:extLst>
                              <a:ext uri="{FF2B5EF4-FFF2-40B4-BE49-F238E27FC236}">
                                <a16:creationId xmlns:a16="http://schemas.microsoft.com/office/drawing/2014/main" id="{B4AEF142-E926-B7A2-B2D1-831BA1F8BD7A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3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491716" y="227445"/>
                            <a:ext cx="3495349" cy="2800686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01E21967-AEA0-E7B5-A17C-A55DBF038535}"/>
                  </a:ext>
                </a:extLst>
              </p:cNvPr>
              <p:cNvSpPr/>
              <p:nvPr/>
            </p:nvSpPr>
            <p:spPr>
              <a:xfrm>
                <a:off x="8835980" y="358751"/>
                <a:ext cx="2997056" cy="2506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4945B9D8-2FF1-74D8-EC8E-E7FB25510823}"/>
                  </a:ext>
                </a:extLst>
              </p:cNvPr>
              <p:cNvSpPr/>
              <p:nvPr/>
            </p:nvSpPr>
            <p:spPr>
              <a:xfrm>
                <a:off x="8835980" y="2450284"/>
                <a:ext cx="2997056" cy="2506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0D1D1FC-52D5-6F37-9391-59695D0197C9}"/>
                </a:ext>
              </a:extLst>
            </p:cNvPr>
            <p:cNvSpPr txBox="1"/>
            <p:nvPr/>
          </p:nvSpPr>
          <p:spPr>
            <a:xfrm>
              <a:off x="2629651" y="276862"/>
              <a:ext cx="243230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           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reast CA ki67 Grade Level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5A8B21C-51BA-B52A-AB44-F97919EA71E6}"/>
                </a:ext>
              </a:extLst>
            </p:cNvPr>
            <p:cNvSpPr txBox="1"/>
            <p:nvPr/>
          </p:nvSpPr>
          <p:spPr>
            <a:xfrm>
              <a:off x="3398705" y="720587"/>
              <a:ext cx="561372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0.07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ECCDAF7-1A04-EF38-5BC1-1C38AA513CCB}"/>
                </a:ext>
              </a:extLst>
            </p:cNvPr>
            <p:cNvSpPr txBox="1"/>
            <p:nvPr/>
          </p:nvSpPr>
          <p:spPr>
            <a:xfrm>
              <a:off x="2236317" y="409416"/>
              <a:ext cx="2584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91569A93-A112-5FFF-157F-48EBC070639F}"/>
                </a:ext>
              </a:extLst>
            </p:cNvPr>
            <p:cNvSpPr/>
            <p:nvPr/>
          </p:nvSpPr>
          <p:spPr>
            <a:xfrm>
              <a:off x="1653658" y="276045"/>
              <a:ext cx="258404" cy="23860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1AC09ED-A3E3-1831-8F08-B6276D43A19A}"/>
                </a:ext>
              </a:extLst>
            </p:cNvPr>
            <p:cNvSpPr txBox="1"/>
            <p:nvPr/>
          </p:nvSpPr>
          <p:spPr>
            <a:xfrm rot="16200000">
              <a:off x="696741" y="1311155"/>
              <a:ext cx="225462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        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R1 Vessels Expression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BB6955A-8B0D-B022-1C9A-18F648ABE1C7}"/>
                </a:ext>
              </a:extLst>
            </p:cNvPr>
            <p:cNvSpPr txBox="1"/>
            <p:nvPr/>
          </p:nvSpPr>
          <p:spPr>
            <a:xfrm>
              <a:off x="2340917" y="234600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BA52EEC-1C2B-34A9-1FEE-6B43F6828634}"/>
                </a:ext>
              </a:extLst>
            </p:cNvPr>
            <p:cNvSpPr txBox="1"/>
            <p:nvPr/>
          </p:nvSpPr>
          <p:spPr>
            <a:xfrm>
              <a:off x="2267179" y="2485919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4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A90B1A5-5BE3-FCB2-CBCC-A07BECBF3065}"/>
                </a:ext>
              </a:extLst>
            </p:cNvPr>
            <p:cNvSpPr txBox="1"/>
            <p:nvPr/>
          </p:nvSpPr>
          <p:spPr>
            <a:xfrm>
              <a:off x="2894692" y="2485919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8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F7F7215-9A83-FB91-F8C0-97E6BBAEFC4B}"/>
                </a:ext>
              </a:extLst>
            </p:cNvPr>
            <p:cNvSpPr txBox="1"/>
            <p:nvPr/>
          </p:nvSpPr>
          <p:spPr>
            <a:xfrm>
              <a:off x="2955372" y="2361516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505E8F0-4220-3336-2A0D-668B362B77AB}"/>
                </a:ext>
              </a:extLst>
            </p:cNvPr>
            <p:cNvSpPr txBox="1"/>
            <p:nvPr/>
          </p:nvSpPr>
          <p:spPr>
            <a:xfrm>
              <a:off x="3552619" y="2357394"/>
              <a:ext cx="2744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+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29FFD11-707A-7E1E-9AD6-4F09679E5D6F}"/>
                </a:ext>
              </a:extLst>
            </p:cNvPr>
            <p:cNvSpPr txBox="1"/>
            <p:nvPr/>
          </p:nvSpPr>
          <p:spPr>
            <a:xfrm>
              <a:off x="4149866" y="2353272"/>
              <a:ext cx="31931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++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EF30605-5C9C-C710-B8C1-CFAB60AF28C4}"/>
                </a:ext>
              </a:extLst>
            </p:cNvPr>
            <p:cNvSpPr txBox="1"/>
            <p:nvPr/>
          </p:nvSpPr>
          <p:spPr>
            <a:xfrm>
              <a:off x="3517375" y="2485919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37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A7487B3-F66B-8F9E-426C-D179AACD2E3E}"/>
                </a:ext>
              </a:extLst>
            </p:cNvPr>
            <p:cNvSpPr txBox="1"/>
            <p:nvPr/>
          </p:nvSpPr>
          <p:spPr>
            <a:xfrm>
              <a:off x="4098570" y="2485919"/>
              <a:ext cx="4219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49 </a:t>
              </a: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F9BF4570-9E2A-8561-6719-6C5B21349451}"/>
                </a:ext>
              </a:extLst>
            </p:cNvPr>
            <p:cNvSpPr/>
            <p:nvPr/>
          </p:nvSpPr>
          <p:spPr>
            <a:xfrm>
              <a:off x="1912061" y="535435"/>
              <a:ext cx="155875" cy="17246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BF7EC59-DDD3-1469-72EA-84419A58B98C}"/>
                </a:ext>
              </a:extLst>
            </p:cNvPr>
            <p:cNvSpPr txBox="1"/>
            <p:nvPr/>
          </p:nvSpPr>
          <p:spPr>
            <a:xfrm>
              <a:off x="1887000" y="513879"/>
              <a:ext cx="248786" cy="1661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29967D31-80D1-4D53-B688-AAD189D1B5C1}"/>
                </a:ext>
              </a:extLst>
            </p:cNvPr>
            <p:cNvSpPr/>
            <p:nvPr/>
          </p:nvSpPr>
          <p:spPr>
            <a:xfrm>
              <a:off x="2852427" y="335784"/>
              <a:ext cx="1949252" cy="2141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52E12D90-31FF-CF87-A1BC-34891CD66E63}"/>
                </a:ext>
              </a:extLst>
            </p:cNvPr>
            <p:cNvGrpSpPr/>
            <p:nvPr/>
          </p:nvGrpSpPr>
          <p:grpSpPr>
            <a:xfrm>
              <a:off x="1715679" y="2556688"/>
              <a:ext cx="3489267" cy="3003848"/>
              <a:chOff x="8563758" y="423534"/>
              <a:chExt cx="3783013" cy="3321050"/>
            </a:xfrm>
          </p:grpSpPr>
          <p:graphicFrame>
            <p:nvGraphicFramePr>
              <p:cNvPr id="62" name="Objeto 8">
                <a:extLst>
                  <a:ext uri="{FF2B5EF4-FFF2-40B4-BE49-F238E27FC236}">
                    <a16:creationId xmlns:a16="http://schemas.microsoft.com/office/drawing/2014/main" id="{E82737B2-97CE-AC29-9F39-6E7206252D46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563758" y="423534"/>
              <a:ext cx="3783013" cy="3321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4" imgW="3797300" imgH="3340100" progId="">
                      <p:embed/>
                    </p:oleObj>
                  </mc:Choice>
                  <mc:Fallback>
                    <p:oleObj r:id="rId4" imgW="3797300" imgH="3340100" progId="">
                      <p:embed/>
                      <p:pic>
                        <p:nvPicPr>
                          <p:cNvPr id="29" name="Objeto 8">
                            <a:extLst>
                              <a:ext uri="{FF2B5EF4-FFF2-40B4-BE49-F238E27FC236}">
                                <a16:creationId xmlns:a16="http://schemas.microsoft.com/office/drawing/2014/main" id="{F9DBCE92-6F62-657B-E38A-659F019A0981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5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563758" y="423534"/>
                            <a:ext cx="3783013" cy="332105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59ADA319-5234-4C27-4D8C-AA94B6517845}"/>
                  </a:ext>
                </a:extLst>
              </p:cNvPr>
              <p:cNvSpPr/>
              <p:nvPr/>
            </p:nvSpPr>
            <p:spPr>
              <a:xfrm>
                <a:off x="8867096" y="475678"/>
                <a:ext cx="3176336" cy="29266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359B584-F1F8-9155-AC10-0A28C69C8419}"/>
                </a:ext>
              </a:extLst>
            </p:cNvPr>
            <p:cNvSpPr txBox="1"/>
            <p:nvPr/>
          </p:nvSpPr>
          <p:spPr>
            <a:xfrm>
              <a:off x="2198294" y="2965834"/>
              <a:ext cx="300665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                Colon CA TMN_M Value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D498D93-CF88-98FB-2426-6F83572E1971}"/>
                </a:ext>
              </a:extLst>
            </p:cNvPr>
            <p:cNvSpPr txBox="1"/>
            <p:nvPr/>
          </p:nvSpPr>
          <p:spPr>
            <a:xfrm>
              <a:off x="2309975" y="3081942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1186B795-F6F0-AF2D-FFAD-698F59B44048}"/>
                </a:ext>
              </a:extLst>
            </p:cNvPr>
            <p:cNvSpPr/>
            <p:nvPr/>
          </p:nvSpPr>
          <p:spPr>
            <a:xfrm>
              <a:off x="2623045" y="2965834"/>
              <a:ext cx="1949252" cy="2141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1266A6A6-D97C-1559-70AC-88C087BD4574}"/>
                </a:ext>
              </a:extLst>
            </p:cNvPr>
            <p:cNvSpPr/>
            <p:nvPr/>
          </p:nvSpPr>
          <p:spPr>
            <a:xfrm>
              <a:off x="2775445" y="3208852"/>
              <a:ext cx="1565890" cy="2141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1D5A387-D533-ED4A-5E6C-C2384F611B00}"/>
                </a:ext>
              </a:extLst>
            </p:cNvPr>
            <p:cNvSpPr txBox="1"/>
            <p:nvPr/>
          </p:nvSpPr>
          <p:spPr>
            <a:xfrm>
              <a:off x="3359250" y="3252806"/>
              <a:ext cx="508473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 = 0.055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F656BCF8-0216-5D6C-C4FD-72F057E5D0E4}"/>
                </a:ext>
              </a:extLst>
            </p:cNvPr>
            <p:cNvSpPr/>
            <p:nvPr/>
          </p:nvSpPr>
          <p:spPr>
            <a:xfrm>
              <a:off x="1836363" y="3053536"/>
              <a:ext cx="395770" cy="2161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A47580A-F728-D750-4A77-EC1F4548BF65}"/>
                </a:ext>
              </a:extLst>
            </p:cNvPr>
            <p:cNvSpPr txBox="1"/>
            <p:nvPr/>
          </p:nvSpPr>
          <p:spPr>
            <a:xfrm>
              <a:off x="2022924" y="3195289"/>
              <a:ext cx="248786" cy="1661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A7E35E6-5A4B-2F6D-B3EC-A90422C715EC}"/>
                </a:ext>
              </a:extLst>
            </p:cNvPr>
            <p:cNvSpPr txBox="1"/>
            <p:nvPr/>
          </p:nvSpPr>
          <p:spPr>
            <a:xfrm rot="16200000">
              <a:off x="971740" y="3949349"/>
              <a:ext cx="181566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        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R3 Tumor Cells</a:t>
              </a:r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E325914B-94C1-0320-554E-68051B9E383B}"/>
                </a:ext>
              </a:extLst>
            </p:cNvPr>
            <p:cNvSpPr/>
            <p:nvPr/>
          </p:nvSpPr>
          <p:spPr>
            <a:xfrm>
              <a:off x="2775445" y="5011027"/>
              <a:ext cx="1679131" cy="2471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C2D4877-C4C2-8559-83D3-B251560C512C}"/>
                </a:ext>
              </a:extLst>
            </p:cNvPr>
            <p:cNvSpPr txBox="1"/>
            <p:nvPr/>
          </p:nvSpPr>
          <p:spPr>
            <a:xfrm>
              <a:off x="2775445" y="4995683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559CF05-0BAF-F6C2-9EB0-EAB96114D4B4}"/>
                </a:ext>
              </a:extLst>
            </p:cNvPr>
            <p:cNvSpPr txBox="1"/>
            <p:nvPr/>
          </p:nvSpPr>
          <p:spPr>
            <a:xfrm>
              <a:off x="4055414" y="4974640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A2B5724-4285-8670-E539-020A264F6D0A}"/>
                </a:ext>
              </a:extLst>
            </p:cNvPr>
            <p:cNvSpPr txBox="1"/>
            <p:nvPr/>
          </p:nvSpPr>
          <p:spPr>
            <a:xfrm>
              <a:off x="2721461" y="5165116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102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AD8AF6D-D64A-1C54-7491-0B6C0B451C96}"/>
                </a:ext>
              </a:extLst>
            </p:cNvPr>
            <p:cNvSpPr txBox="1"/>
            <p:nvPr/>
          </p:nvSpPr>
          <p:spPr>
            <a:xfrm>
              <a:off x="4020062" y="5165116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8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B6D0CD6-F74A-4AF0-7C28-1FF9385D297E}"/>
                </a:ext>
              </a:extLst>
            </p:cNvPr>
            <p:cNvSpPr txBox="1"/>
            <p:nvPr/>
          </p:nvSpPr>
          <p:spPr>
            <a:xfrm>
              <a:off x="2449777" y="2662091"/>
              <a:ext cx="20789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reast CA ki67 Grade Level</a:t>
              </a:r>
            </a:p>
          </p:txBody>
        </p: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E4778F06-1173-7455-1A0C-2FA9C7C43134}"/>
                </a:ext>
              </a:extLst>
            </p:cNvPr>
            <p:cNvGrpSpPr/>
            <p:nvPr/>
          </p:nvGrpSpPr>
          <p:grpSpPr>
            <a:xfrm>
              <a:off x="1870484" y="5289251"/>
              <a:ext cx="3591352" cy="3018375"/>
              <a:chOff x="8684804" y="3289865"/>
              <a:chExt cx="3591352" cy="3018375"/>
            </a:xfrm>
          </p:grpSpPr>
          <p:graphicFrame>
            <p:nvGraphicFramePr>
              <p:cNvPr id="80" name="Objeto 9">
                <a:extLst>
                  <a:ext uri="{FF2B5EF4-FFF2-40B4-BE49-F238E27FC236}">
                    <a16:creationId xmlns:a16="http://schemas.microsoft.com/office/drawing/2014/main" id="{BE91E025-0D79-D80E-0EBE-B8F5090639F2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684804" y="3289865"/>
              <a:ext cx="3591352" cy="30183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6" imgW="3797300" imgH="3340100" progId="">
                      <p:embed/>
                    </p:oleObj>
                  </mc:Choice>
                  <mc:Fallback>
                    <p:oleObj r:id="rId6" imgW="3797300" imgH="3340100" progId="">
                      <p:embed/>
                      <p:pic>
                        <p:nvPicPr>
                          <p:cNvPr id="25" name="Objeto 9">
                            <a:extLst>
                              <a:ext uri="{FF2B5EF4-FFF2-40B4-BE49-F238E27FC236}">
                                <a16:creationId xmlns:a16="http://schemas.microsoft.com/office/drawing/2014/main" id="{51095E0C-4B28-3599-FBF9-14B5C7883094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7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684804" y="3289865"/>
                            <a:ext cx="3591352" cy="30183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BFCF9429-99CC-9F27-3B36-1B350FFF40EC}"/>
                  </a:ext>
                </a:extLst>
              </p:cNvPr>
              <p:cNvSpPr/>
              <p:nvPr/>
            </p:nvSpPr>
            <p:spPr>
              <a:xfrm>
                <a:off x="9275543" y="3332875"/>
                <a:ext cx="2591521" cy="26827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BB7A14B-C31E-5BB4-EC44-26F07E73A067}"/>
                </a:ext>
              </a:extLst>
            </p:cNvPr>
            <p:cNvSpPr txBox="1"/>
            <p:nvPr/>
          </p:nvSpPr>
          <p:spPr>
            <a:xfrm>
              <a:off x="2303657" y="5571989"/>
              <a:ext cx="300665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                Colon CA TMN_N Value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8BD04C12-F23B-BCA1-490B-934D28897E64}"/>
                </a:ext>
              </a:extLst>
            </p:cNvPr>
            <p:cNvSpPr txBox="1"/>
            <p:nvPr/>
          </p:nvSpPr>
          <p:spPr>
            <a:xfrm>
              <a:off x="2871190" y="5907786"/>
              <a:ext cx="859531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p = 0.058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F3B4CF2C-69E2-B1AD-D860-30C373686D20}"/>
                </a:ext>
              </a:extLst>
            </p:cNvPr>
            <p:cNvSpPr/>
            <p:nvPr/>
          </p:nvSpPr>
          <p:spPr>
            <a:xfrm>
              <a:off x="2552778" y="7737633"/>
              <a:ext cx="2172342" cy="2471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67858311-6E80-F0F0-8133-A9B2A1BC15F5}"/>
                </a:ext>
              </a:extLst>
            </p:cNvPr>
            <p:cNvSpPr/>
            <p:nvPr/>
          </p:nvSpPr>
          <p:spPr>
            <a:xfrm>
              <a:off x="2847441" y="5599844"/>
              <a:ext cx="1949252" cy="2141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7E3BC4B7-0F3C-F45C-9618-EE0B6C87748B}"/>
                </a:ext>
              </a:extLst>
            </p:cNvPr>
            <p:cNvSpPr/>
            <p:nvPr/>
          </p:nvSpPr>
          <p:spPr>
            <a:xfrm>
              <a:off x="2610002" y="5927546"/>
              <a:ext cx="1565890" cy="2141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8742B66-ED0E-341F-F319-4D90557309D6}"/>
                </a:ext>
              </a:extLst>
            </p:cNvPr>
            <p:cNvSpPr txBox="1"/>
            <p:nvPr/>
          </p:nvSpPr>
          <p:spPr>
            <a:xfrm>
              <a:off x="3059970" y="6016380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 = 0.058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95574A1-0551-46D0-B8A4-3910AB91AE2E}"/>
                </a:ext>
              </a:extLst>
            </p:cNvPr>
            <p:cNvSpPr/>
            <p:nvPr/>
          </p:nvSpPr>
          <p:spPr>
            <a:xfrm>
              <a:off x="1990907" y="5654390"/>
              <a:ext cx="395770" cy="2161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370C8BE1-661E-693C-31A0-ABC3BF5F3657}"/>
                </a:ext>
              </a:extLst>
            </p:cNvPr>
            <p:cNvSpPr txBox="1"/>
            <p:nvPr/>
          </p:nvSpPr>
          <p:spPr>
            <a:xfrm rot="16200000">
              <a:off x="1022811" y="6687237"/>
              <a:ext cx="210315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            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R3 Tumor Cells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3556651-09B9-735D-99BB-CC8B9CC98A42}"/>
                </a:ext>
              </a:extLst>
            </p:cNvPr>
            <p:cNvSpPr txBox="1"/>
            <p:nvPr/>
          </p:nvSpPr>
          <p:spPr>
            <a:xfrm>
              <a:off x="2161374" y="5948976"/>
              <a:ext cx="248786" cy="1661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8CCC86D-9D6B-CF09-3460-B589D68723C9}"/>
                </a:ext>
              </a:extLst>
            </p:cNvPr>
            <p:cNvSpPr txBox="1"/>
            <p:nvPr/>
          </p:nvSpPr>
          <p:spPr>
            <a:xfrm>
              <a:off x="2718503" y="7853638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7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3252C20-B26C-1B15-7586-8BAE4ED9C5D8}"/>
                </a:ext>
              </a:extLst>
            </p:cNvPr>
            <p:cNvSpPr txBox="1"/>
            <p:nvPr/>
          </p:nvSpPr>
          <p:spPr>
            <a:xfrm>
              <a:off x="3570417" y="7853638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2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35F6406-030C-EE2F-7E1D-9B47BCB40591}"/>
                </a:ext>
              </a:extLst>
            </p:cNvPr>
            <p:cNvSpPr txBox="1"/>
            <p:nvPr/>
          </p:nvSpPr>
          <p:spPr>
            <a:xfrm>
              <a:off x="4450035" y="7853638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1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4B75CD2-F15A-87D1-AD8F-A9899AF0825D}"/>
                </a:ext>
              </a:extLst>
            </p:cNvPr>
            <p:cNvSpPr txBox="1"/>
            <p:nvPr/>
          </p:nvSpPr>
          <p:spPr>
            <a:xfrm>
              <a:off x="2759829" y="7722654"/>
              <a:ext cx="2840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E9FD7AF-BC4B-4FA1-82C2-0497CB634024}"/>
                </a:ext>
              </a:extLst>
            </p:cNvPr>
            <p:cNvSpPr txBox="1"/>
            <p:nvPr/>
          </p:nvSpPr>
          <p:spPr>
            <a:xfrm>
              <a:off x="3628927" y="7722654"/>
              <a:ext cx="2840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FC15019-0877-2F4C-1010-6E666DB2BD0C}"/>
                </a:ext>
              </a:extLst>
            </p:cNvPr>
            <p:cNvSpPr txBox="1"/>
            <p:nvPr/>
          </p:nvSpPr>
          <p:spPr>
            <a:xfrm>
              <a:off x="4498025" y="7722654"/>
              <a:ext cx="2840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91C3B049-0660-02D6-0962-7D60217ADA3F}"/>
                </a:ext>
              </a:extLst>
            </p:cNvPr>
            <p:cNvSpPr txBox="1"/>
            <p:nvPr/>
          </p:nvSpPr>
          <p:spPr>
            <a:xfrm>
              <a:off x="2475299" y="581660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980FB7F7-6534-4599-20EA-74111945816E}"/>
                </a:ext>
              </a:extLst>
            </p:cNvPr>
            <p:cNvSpPr txBox="1"/>
            <p:nvPr/>
          </p:nvSpPr>
          <p:spPr>
            <a:xfrm>
              <a:off x="2617914" y="5296825"/>
              <a:ext cx="184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lon CA TMN_M Value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FDDCAE8F-77A6-8810-5F23-F4FC1BCC4DFD}"/>
                </a:ext>
              </a:extLst>
            </p:cNvPr>
            <p:cNvGrpSpPr/>
            <p:nvPr/>
          </p:nvGrpSpPr>
          <p:grpSpPr>
            <a:xfrm>
              <a:off x="2007455" y="8004645"/>
              <a:ext cx="3335439" cy="2913346"/>
              <a:chOff x="7431768" y="285750"/>
              <a:chExt cx="3778250" cy="3321050"/>
            </a:xfrm>
          </p:grpSpPr>
          <p:graphicFrame>
            <p:nvGraphicFramePr>
              <p:cNvPr id="16" name="Objeto 7">
                <a:extLst>
                  <a:ext uri="{FF2B5EF4-FFF2-40B4-BE49-F238E27FC236}">
                    <a16:creationId xmlns:a16="http://schemas.microsoft.com/office/drawing/2014/main" id="{E0BA783F-7907-0893-15CB-7F7EE5031BAE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7431768" y="285750"/>
              <a:ext cx="3778250" cy="3321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8" imgW="3797300" imgH="3340100" progId="">
                      <p:embed/>
                    </p:oleObj>
                  </mc:Choice>
                  <mc:Fallback>
                    <p:oleObj r:id="rId8" imgW="3797300" imgH="3340100" progId="">
                      <p:embed/>
                      <p:pic>
                        <p:nvPicPr>
                          <p:cNvPr id="8" name="Objeto 7">
                            <a:extLst>
                              <a:ext uri="{FF2B5EF4-FFF2-40B4-BE49-F238E27FC236}">
                                <a16:creationId xmlns:a16="http://schemas.microsoft.com/office/drawing/2014/main" id="{67E73B00-E3AA-F45B-C4CF-2B77295A816E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9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7431768" y="285750"/>
                            <a:ext cx="3778250" cy="332105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9755C9D2-6466-1F96-8EC1-9CC02B884804}"/>
                  </a:ext>
                </a:extLst>
              </p:cNvPr>
              <p:cNvSpPr/>
              <p:nvPr/>
            </p:nvSpPr>
            <p:spPr>
              <a:xfrm>
                <a:off x="7777439" y="340181"/>
                <a:ext cx="3254034" cy="31490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C9DE9E0-11EC-EC59-D9EF-B2E20FDEEA12}"/>
                </a:ext>
              </a:extLst>
            </p:cNvPr>
            <p:cNvSpPr txBox="1"/>
            <p:nvPr/>
          </p:nvSpPr>
          <p:spPr>
            <a:xfrm>
              <a:off x="2340917" y="10702606"/>
              <a:ext cx="261976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               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ostate CA TMN_T Value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A401407E-C760-03DD-603E-4DF43B662DE3}"/>
                </a:ext>
              </a:extLst>
            </p:cNvPr>
            <p:cNvSpPr/>
            <p:nvPr/>
          </p:nvSpPr>
          <p:spPr>
            <a:xfrm rot="16200000">
              <a:off x="1327804" y="9272180"/>
              <a:ext cx="1949932" cy="3708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02AFB16-E888-2CF1-6895-B5CBA73AE99E}"/>
                </a:ext>
              </a:extLst>
            </p:cNvPr>
            <p:cNvSpPr txBox="1"/>
            <p:nvPr/>
          </p:nvSpPr>
          <p:spPr>
            <a:xfrm rot="16200000">
              <a:off x="1438776" y="9262146"/>
              <a:ext cx="13528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R3 Tumor Cells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956869A2-7413-4A49-97FA-E1390C7450FC}"/>
                </a:ext>
              </a:extLst>
            </p:cNvPr>
            <p:cNvSpPr/>
            <p:nvPr/>
          </p:nvSpPr>
          <p:spPr>
            <a:xfrm>
              <a:off x="3767339" y="8624470"/>
              <a:ext cx="717462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A3ECDD8-312C-4FCD-582B-81FAE2DF2FFD}"/>
                </a:ext>
              </a:extLst>
            </p:cNvPr>
            <p:cNvSpPr txBox="1"/>
            <p:nvPr/>
          </p:nvSpPr>
          <p:spPr>
            <a:xfrm>
              <a:off x="3918807" y="8688339"/>
              <a:ext cx="508473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 = 0.013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8B8274E-9232-9DCE-4321-DE2C778932DB}"/>
                </a:ext>
              </a:extLst>
            </p:cNvPr>
            <p:cNvSpPr txBox="1"/>
            <p:nvPr/>
          </p:nvSpPr>
          <p:spPr>
            <a:xfrm>
              <a:off x="2209597" y="8610558"/>
              <a:ext cx="248786" cy="1615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</a:p>
            <a:p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55E42D4-2DF5-AF9F-3C8B-5C79F4A5FBDF}"/>
                </a:ext>
              </a:extLst>
            </p:cNvPr>
            <p:cNvSpPr/>
            <p:nvPr/>
          </p:nvSpPr>
          <p:spPr>
            <a:xfrm>
              <a:off x="2708799" y="10364933"/>
              <a:ext cx="2016321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FC152C5-BFDE-3CE6-5F9F-33B75B179203}"/>
                </a:ext>
              </a:extLst>
            </p:cNvPr>
            <p:cNvSpPr txBox="1"/>
            <p:nvPr/>
          </p:nvSpPr>
          <p:spPr>
            <a:xfrm>
              <a:off x="2806903" y="10368385"/>
              <a:ext cx="2744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1900893-2D4A-0D2F-A72E-30EBB3C626C3}"/>
                </a:ext>
              </a:extLst>
            </p:cNvPr>
            <p:cNvSpPr txBox="1"/>
            <p:nvPr/>
          </p:nvSpPr>
          <p:spPr>
            <a:xfrm>
              <a:off x="3602047" y="10368385"/>
              <a:ext cx="2744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29CDC8F-314B-1144-9254-0ACED9B26439}"/>
                </a:ext>
              </a:extLst>
            </p:cNvPr>
            <p:cNvSpPr txBox="1"/>
            <p:nvPr/>
          </p:nvSpPr>
          <p:spPr>
            <a:xfrm>
              <a:off x="4440608" y="10368385"/>
              <a:ext cx="2744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8982F8A-9742-9B29-D548-6EA7565757A2}"/>
                </a:ext>
              </a:extLst>
            </p:cNvPr>
            <p:cNvSpPr txBox="1"/>
            <p:nvPr/>
          </p:nvSpPr>
          <p:spPr>
            <a:xfrm>
              <a:off x="2751738" y="10493780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39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4785C9C-FC4E-78E7-64B7-92DC69AE698F}"/>
                </a:ext>
              </a:extLst>
            </p:cNvPr>
            <p:cNvSpPr txBox="1"/>
            <p:nvPr/>
          </p:nvSpPr>
          <p:spPr>
            <a:xfrm>
              <a:off x="3570048" y="10493780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6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9EDAEBD-5DDE-42D9-DD2C-9BB991999C20}"/>
                </a:ext>
              </a:extLst>
            </p:cNvPr>
            <p:cNvSpPr txBox="1"/>
            <p:nvPr/>
          </p:nvSpPr>
          <p:spPr>
            <a:xfrm>
              <a:off x="4398930" y="10493780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 = 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8C66981-2C39-ADB4-9002-6FF45EAF12E7}"/>
                </a:ext>
              </a:extLst>
            </p:cNvPr>
            <p:cNvSpPr txBox="1"/>
            <p:nvPr/>
          </p:nvSpPr>
          <p:spPr>
            <a:xfrm>
              <a:off x="2568379" y="8494577"/>
              <a:ext cx="2883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724A613-58DE-03E7-C58D-D7F736998473}"/>
                </a:ext>
              </a:extLst>
            </p:cNvPr>
            <p:cNvSpPr txBox="1"/>
            <p:nvPr/>
          </p:nvSpPr>
          <p:spPr>
            <a:xfrm>
              <a:off x="2818632" y="8065243"/>
              <a:ext cx="190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lon CA TMN_N Values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9D71390E-B108-B914-EEA5-EB54E621C638}"/>
              </a:ext>
            </a:extLst>
          </p:cNvPr>
          <p:cNvSpPr txBox="1"/>
          <p:nvPr/>
        </p:nvSpPr>
        <p:spPr>
          <a:xfrm>
            <a:off x="2463278" y="11439333"/>
            <a:ext cx="2428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</a:t>
            </a:r>
            <a:r>
              <a:rPr lang="en-US" b="1"/>
              <a:t>Figure S2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6721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0</TotalTime>
  <Words>149</Words>
  <Application>Microsoft Office PowerPoint</Application>
  <PresentationFormat>Widescreen</PresentationFormat>
  <Paragraphs>1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ttitta, Frank (NIH/NCI) [V]</dc:creator>
  <cp:lastModifiedBy>MDPI</cp:lastModifiedBy>
  <cp:revision>8</cp:revision>
  <cp:lastPrinted>2024-08-08T19:54:19Z</cp:lastPrinted>
  <dcterms:created xsi:type="dcterms:W3CDTF">2023-04-11T23:34:45Z</dcterms:created>
  <dcterms:modified xsi:type="dcterms:W3CDTF">2024-10-23T05:33:17Z</dcterms:modified>
</cp:coreProperties>
</file>